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in Wang" initials="L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7F5"/>
    <a:srgbClr val="595959"/>
    <a:srgbClr val="C00000"/>
    <a:srgbClr val="2C251B"/>
    <a:srgbClr val="262219"/>
    <a:srgbClr val="FCFDF5"/>
    <a:srgbClr val="573EEE"/>
    <a:srgbClr val="E7E6E6"/>
    <a:srgbClr val="FFE1E1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3826" autoAdjust="0"/>
  </p:normalViewPr>
  <p:slideViewPr>
    <p:cSldViewPr snapToGrid="0" showGuides="1">
      <p:cViewPr>
        <p:scale>
          <a:sx n="123" d="100"/>
          <a:sy n="123" d="100"/>
        </p:scale>
        <p:origin x="-168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C98CC-2AF8-4FD9-9E7C-A0C24A633DA4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B2C4D-6130-4C66-A9EA-5780B903F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24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D041859-A63D-D772-A264-D8268EED4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6CCCB1A6-1850-A204-EFC8-935362ED36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E6D255A-D39E-1B89-DA22-0D857B19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4B678B-4D53-0E79-94FE-D89F62B8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5BB68D-1861-C39F-CD55-5EAF6F274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03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BC58309-37E9-1FA2-1B15-848BA5953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7F40BB7-8014-3649-D669-7DC7C0F4F1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0CA863B-B0B0-A8AE-B6C6-211D398A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A641A1-65C2-AC4B-AA6D-4CC2A6F1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F6CADC-D53C-BBEF-A153-069C3F45C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5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9F0F66F-44D4-93F8-08CE-6060D460B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75C86ED-E11C-8312-1A8B-3015B5557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2627D1-5E73-95CF-1A8F-4CA518906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EF8AB0-7893-F50A-DFE5-D548AFEA1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C3F96BB-937C-9DA4-34DA-F6D0E319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22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F29EE3-B57C-5B3E-B03F-A49145BD0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DA8F29E-75A5-C7EF-8C94-DD2E429D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83F43F0-2694-FF88-78ED-A4F86167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C0A3F80-0733-EAFF-5BBC-4C2B8EAE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160031D-F379-50CF-D5CF-627155DD1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09319F5-5DA5-9777-E5F7-92F893FD9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BA2A9E-22C3-625A-E97D-6DA5C6DA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D09C20-3367-D648-05B2-5630C80C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AAA057-182E-2F17-1686-1627B967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E8B3F7B-D124-9E9F-650C-AD66A593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621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C0D69B-0AF0-4823-0B0C-FCA6F3062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A45F1B8-6FA9-F24E-A7B8-E672AF89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C4F2021-F9B3-6ECB-D948-7D2A1DD6D6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ABB24F3-5725-87D6-E596-B25563D2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97705-2118-3264-0F31-A80E7A21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FBD48A-BC60-93F4-E65C-6C560EF6D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0053EA-AE41-F280-5C1C-352EAD13F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02D215F-4217-D2B2-022B-B79132450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5ED1F03-6DE3-5E96-B4A1-F0B5B9244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9E9A00A-1253-B556-C711-90E0D9CD1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7B20BFC-6726-7EA4-45C1-001E7CA10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2C2CAF60-8F40-32A4-068A-474CDBD8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842D5F02-0794-D1BA-6054-4EADCC5C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5106776-BCBE-0D05-FFC8-6CEDF1707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0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B0CD0A0-B730-A5E5-3AF9-DA822D14C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D9C14C3-5393-947A-81BD-9E40267E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D4FB42A-A748-F389-4177-012B41EF7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4C4E2B1-EE5D-47F8-C366-BC6F5CA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5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AC2C951-38E1-7D03-02A6-D3C4F66E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9157E7-65B4-C99E-8A5D-3966C32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F0F7DD2-8152-32C2-A0B8-0A471C87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85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4A0391-7DA4-1AA4-024D-DF0ABD123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4B7E594-C022-3DF4-D8BC-13F5A4FBE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9405772-C60A-77FF-AA27-5EBF564E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78505BA-4623-0389-1BBF-160FA8F7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51683F-751B-19E4-C89D-7D64AB2BA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AB07C7A-955A-F336-9011-6471032A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21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2DF8BB-3530-80BF-3D66-33BB2E525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79EC588-70BA-CF47-0B47-C04ED16DD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360A111-2847-A058-9B2F-7470F593D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7929C5E-750D-3298-7420-F93DF6CE6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F35BD6E-F04D-8DA7-09D5-59A32A95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952210B-FD69-EA75-EE82-F54B33E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13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FED5CF-2DF1-DD15-5CE9-056C18840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13C1FD7-0222-4016-BDC5-A8233C651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CDB123-0A5E-D472-0340-78BF53820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524D42-5138-E142-973C-A7CCDEE0E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1940A24-1140-DA84-5533-9A882C3BD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19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6.png"/><Relationship Id="rId26" Type="http://schemas.openxmlformats.org/officeDocument/2006/relationships/image" Target="../media/image20.png"/><Relationship Id="rId3" Type="http://schemas.openxmlformats.org/officeDocument/2006/relationships/image" Target="../media/image2.png"/><Relationship Id="rId21" Type="http://schemas.openxmlformats.org/officeDocument/2006/relationships/image" Target="../media/image42.sv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5.png"/><Relationship Id="rId25" Type="http://schemas.openxmlformats.org/officeDocument/2006/relationships/image" Target="../media/image46.svg"/><Relationship Id="rId2" Type="http://schemas.openxmlformats.org/officeDocument/2006/relationships/image" Target="../media/image1.jpeg"/><Relationship Id="rId16" Type="http://schemas.openxmlformats.org/officeDocument/2006/relationships/image" Target="../media/image37.svg"/><Relationship Id="rId20" Type="http://schemas.openxmlformats.org/officeDocument/2006/relationships/image" Target="../media/image17.png"/><Relationship Id="rId29" Type="http://schemas.openxmlformats.org/officeDocument/2006/relationships/image" Target="../media/image50.sv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19.pn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23" Type="http://schemas.openxmlformats.org/officeDocument/2006/relationships/image" Target="../media/image44.svg"/><Relationship Id="rId28" Type="http://schemas.openxmlformats.org/officeDocument/2006/relationships/image" Target="../media/image21.png"/><Relationship Id="rId10" Type="http://schemas.openxmlformats.org/officeDocument/2006/relationships/image" Target="../media/image9.png"/><Relationship Id="rId19" Type="http://schemas.openxmlformats.org/officeDocument/2006/relationships/image" Target="../media/image40.sv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18.png"/><Relationship Id="rId27" Type="http://schemas.openxmlformats.org/officeDocument/2006/relationships/image" Target="../media/image4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组合 31">
            <a:extLst>
              <a:ext uri="{FF2B5EF4-FFF2-40B4-BE49-F238E27FC236}">
                <a16:creationId xmlns:a16="http://schemas.microsoft.com/office/drawing/2014/main" xmlns="" id="{99582A09-5325-49DB-9FE2-C49028963E0B}"/>
              </a:ext>
            </a:extLst>
          </p:cNvPr>
          <p:cNvGrpSpPr/>
          <p:nvPr/>
        </p:nvGrpSpPr>
        <p:grpSpPr>
          <a:xfrm>
            <a:off x="1405308" y="904399"/>
            <a:ext cx="3204703" cy="5291884"/>
            <a:chOff x="1202231" y="228543"/>
            <a:chExt cx="4664557" cy="4105594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xmlns="" id="{7AF9129D-57ED-4DFC-B1F6-830A66101C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2231" y="228543"/>
              <a:ext cx="4508057" cy="4105594"/>
            </a:xfrm>
            <a:prstGeom prst="rect">
              <a:avLst/>
            </a:prstGeom>
          </p:spPr>
        </p:pic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xmlns="" id="{E9C8FA9A-5583-4B01-B503-8D207D29E7D9}"/>
                </a:ext>
              </a:extLst>
            </p:cNvPr>
            <p:cNvGrpSpPr/>
            <p:nvPr/>
          </p:nvGrpSpPr>
          <p:grpSpPr>
            <a:xfrm>
              <a:off x="4930877" y="317995"/>
              <a:ext cx="935911" cy="3998277"/>
              <a:chOff x="4930877" y="317995"/>
              <a:chExt cx="935911" cy="3998277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xmlns="" id="{54718794-62E8-4DAD-9C8E-0120B699D72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57586" y="2563962"/>
                <a:ext cx="662417" cy="35175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xmlns="" id="{4D3DBB1D-F12A-48A3-B225-761E275E18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57584" y="3007891"/>
                <a:ext cx="662417" cy="328958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pic>
            <p:nvPicPr>
              <p:cNvPr id="28" name="Picture 2" descr="æ¥çæºå¾å">
                <a:extLst>
                  <a:ext uri="{FF2B5EF4-FFF2-40B4-BE49-F238E27FC236}">
                    <a16:creationId xmlns:a16="http://schemas.microsoft.com/office/drawing/2014/main" xmlns="" id="{229521A2-9DCC-461D-AAC3-C36386C0D6C3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43249" y="317995"/>
                <a:ext cx="661718" cy="35208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xmlns="" id="{02535C8A-7337-4EB3-B862-4872ABF6EDD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16" r="20768" b="-1"/>
              <a:stretch/>
            </p:blipFill>
            <p:spPr>
              <a:xfrm>
                <a:off x="5044580" y="754191"/>
                <a:ext cx="662417" cy="35197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xmlns="" id="{1482A2E1-378E-416C-B822-E150D506830D}"/>
                  </a:ext>
                </a:extLst>
              </p:cNvPr>
              <p:cNvSpPr txBox="1"/>
              <p:nvPr/>
            </p:nvSpPr>
            <p:spPr>
              <a:xfrm>
                <a:off x="5000310" y="1081208"/>
                <a:ext cx="844450" cy="1074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300" b="1" i="1" dirty="0" err="1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Ceratodon</a:t>
                </a:r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 </a:t>
                </a:r>
                <a:r>
                  <a:rPr lang="en-US" altLang="zh-CN" sz="300" b="1" i="1" dirty="0" err="1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purpureus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xmlns="" id="{D60728A2-F771-4608-9D57-52DD7937BA3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46293" y="1199914"/>
                <a:ext cx="662417" cy="35175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xmlns="" id="{075386A3-545A-4719-93EF-5A1CB70DA491}"/>
                  </a:ext>
                </a:extLst>
              </p:cNvPr>
              <p:cNvSpPr txBox="1"/>
              <p:nvPr/>
            </p:nvSpPr>
            <p:spPr>
              <a:xfrm>
                <a:off x="5016679" y="1529139"/>
                <a:ext cx="778178" cy="1074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 Carya </a:t>
                </a:r>
                <a:r>
                  <a:rPr lang="en-US" altLang="zh-CN" sz="300" b="1" i="1" dirty="0" err="1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illinoinensis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xmlns="" id="{4AD690C7-9BF7-4654-A4D3-C5820CC68C3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61725" y="1643770"/>
                <a:ext cx="662417" cy="35175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xmlns="" id="{5C4F3C40-EB6F-42B8-A06B-AA2CA3054375}"/>
                  </a:ext>
                </a:extLst>
              </p:cNvPr>
              <p:cNvSpPr txBox="1"/>
              <p:nvPr/>
            </p:nvSpPr>
            <p:spPr>
              <a:xfrm>
                <a:off x="5041080" y="1964320"/>
                <a:ext cx="716214" cy="1074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Musa acuminata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xmlns="" id="{DABBAEC0-1076-4AFD-9745-86BDA7E9FE5F}"/>
                  </a:ext>
                </a:extLst>
              </p:cNvPr>
              <p:cNvSpPr txBox="1"/>
              <p:nvPr/>
            </p:nvSpPr>
            <p:spPr>
              <a:xfrm>
                <a:off x="4989062" y="2890615"/>
                <a:ext cx="805360" cy="11210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Manihot esculenta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xmlns="" id="{F42A1A4F-463A-406D-BE2A-CCB960B998B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61715" y="2089375"/>
                <a:ext cx="662508" cy="369082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xmlns="" id="{F58A926D-F348-46AA-A0D4-FEFA2DBCBC89}"/>
                  </a:ext>
                </a:extLst>
              </p:cNvPr>
              <p:cNvSpPr txBox="1"/>
              <p:nvPr/>
            </p:nvSpPr>
            <p:spPr>
              <a:xfrm>
                <a:off x="5043249" y="2434143"/>
                <a:ext cx="701609" cy="1054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Sorghum bicolor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xmlns="" id="{822F19F2-50FD-4A4A-95EC-811AAF6D4E77}"/>
                  </a:ext>
                </a:extLst>
              </p:cNvPr>
              <p:cNvSpPr txBox="1"/>
              <p:nvPr/>
            </p:nvSpPr>
            <p:spPr>
              <a:xfrm>
                <a:off x="5038481" y="3311527"/>
                <a:ext cx="805360" cy="11210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Pyrus </a:t>
                </a:r>
                <a:r>
                  <a:rPr lang="en-US" altLang="zh-CN" sz="300" b="1" i="1" dirty="0" err="1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bretschneideri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xmlns="" id="{11AD45E6-51B2-46BC-B8E4-936F5C6E703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57583" y="3428868"/>
                <a:ext cx="662419" cy="35175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xmlns="" id="{A259BB85-46C8-49C2-876B-C85003CBEE2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57582" y="3873713"/>
                <a:ext cx="662420" cy="351751"/>
              </a:xfrm>
              <a:prstGeom prst="roundRect">
                <a:avLst>
                  <a:gd name="adj" fmla="val 8594"/>
                </a:avLst>
              </a:prstGeom>
              <a:solidFill>
                <a:srgbClr val="FFFFFF">
                  <a:shade val="85000"/>
                </a:srgbClr>
              </a:solidFill>
              <a:ln>
                <a:noFill/>
              </a:ln>
              <a:effectLst>
                <a:reflection blurRad="12700" stA="38000" endPos="28000" dist="5000" dir="5400000" sy="-100000" algn="bl" rotWithShape="0"/>
              </a:effectLst>
            </p:spPr>
          </p:pic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xmlns="" id="{7BAF53FD-16C6-4D80-8B74-55DC7CF0B9CF}"/>
                  </a:ext>
                </a:extLst>
              </p:cNvPr>
              <p:cNvSpPr txBox="1"/>
              <p:nvPr/>
            </p:nvSpPr>
            <p:spPr>
              <a:xfrm>
                <a:off x="4971875" y="3765015"/>
                <a:ext cx="805360" cy="11210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Arabidopsis thaliana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xmlns="" id="{BD1F288A-30FE-478C-8FBD-0DD450590B40}"/>
                  </a:ext>
                </a:extLst>
              </p:cNvPr>
              <p:cNvSpPr txBox="1"/>
              <p:nvPr/>
            </p:nvSpPr>
            <p:spPr>
              <a:xfrm>
                <a:off x="4966849" y="4204165"/>
                <a:ext cx="892586" cy="11210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Anacardium occidentale</a:t>
                </a:r>
                <a:endParaRPr lang="zh-CN" altLang="en-US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xmlns="" id="{9F46491A-24A5-4D04-81DF-7D0E975807B4}"/>
                  </a:ext>
                </a:extLst>
              </p:cNvPr>
              <p:cNvSpPr txBox="1"/>
              <p:nvPr/>
            </p:nvSpPr>
            <p:spPr>
              <a:xfrm>
                <a:off x="4930877" y="641447"/>
                <a:ext cx="935911" cy="1074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300" b="1" i="1" dirty="0" err="1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Ostreococcus</a:t>
                </a:r>
                <a:r>
                  <a:rPr lang="en-US" altLang="zh-CN" sz="300" b="1" i="1" dirty="0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 </a:t>
                </a:r>
                <a:r>
                  <a:rPr lang="en-US" altLang="zh-CN" sz="300" b="1" i="1" dirty="0" err="1">
                    <a:latin typeface="Bodoni MT" panose="02070603080606020203" pitchFamily="18" charset="0"/>
                    <a:ea typeface="Microsoft YaHei" panose="020B0503020204020204" pitchFamily="34" charset="-122"/>
                  </a:rPr>
                  <a:t>lucimarinus</a:t>
                </a:r>
                <a:endParaRPr lang="en-US" altLang="zh-CN" sz="300" b="1" i="1" dirty="0">
                  <a:latin typeface="Bodoni MT" panose="02070603080606020203" pitchFamily="18" charset="0"/>
                  <a:ea typeface="Microsoft YaHei" panose="020B0503020204020204" pitchFamily="34" charset="-122"/>
                </a:endParaRPr>
              </a:p>
            </p:txBody>
          </p:sp>
        </p:grpSp>
      </p:grpSp>
      <p:sp>
        <p:nvSpPr>
          <p:cNvPr id="29" name="矩形 28">
            <a:extLst>
              <a:ext uri="{FF2B5EF4-FFF2-40B4-BE49-F238E27FC236}">
                <a16:creationId xmlns:a16="http://schemas.microsoft.com/office/drawing/2014/main" xmlns="" id="{D95049BD-6551-4B69-925B-C9193A8A938E}"/>
              </a:ext>
            </a:extLst>
          </p:cNvPr>
          <p:cNvSpPr/>
          <p:nvPr/>
        </p:nvSpPr>
        <p:spPr>
          <a:xfrm>
            <a:off x="1335440" y="854129"/>
            <a:ext cx="3257148" cy="5400000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xmlns="" id="{9A971F5F-C7BF-47D1-B044-F295B7427CDC}"/>
              </a:ext>
            </a:extLst>
          </p:cNvPr>
          <p:cNvSpPr/>
          <p:nvPr/>
        </p:nvSpPr>
        <p:spPr>
          <a:xfrm>
            <a:off x="4592588" y="854130"/>
            <a:ext cx="6363412" cy="3826457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aseline="-25000" dirty="0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xmlns="" id="{AD89D334-FA33-4ED7-B6E8-120174E39283}"/>
              </a:ext>
            </a:extLst>
          </p:cNvPr>
          <p:cNvSpPr/>
          <p:nvPr/>
        </p:nvSpPr>
        <p:spPr>
          <a:xfrm>
            <a:off x="1341875" y="856373"/>
            <a:ext cx="430851" cy="26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xmlns="" id="{9829367C-E3DD-4BC3-236D-6318B6104FE3}"/>
              </a:ext>
            </a:extLst>
          </p:cNvPr>
          <p:cNvSpPr/>
          <p:nvPr/>
        </p:nvSpPr>
        <p:spPr>
          <a:xfrm>
            <a:off x="4596293" y="864851"/>
            <a:ext cx="430851" cy="27508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AD1F3B95-501F-3550-4594-5997AEF62C37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3113" y="1663840"/>
            <a:ext cx="1620000" cy="162000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3396DFC8-5B4D-C3E5-EBBD-0E1EFB302FF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26497"/>
          <a:stretch/>
        </p:blipFill>
        <p:spPr>
          <a:xfrm>
            <a:off x="6879833" y="5008544"/>
            <a:ext cx="4003535" cy="1173589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xmlns="" id="{3D9AA522-A893-8713-CDC0-8633FC008DDB}"/>
              </a:ext>
            </a:extLst>
          </p:cNvPr>
          <p:cNvSpPr/>
          <p:nvPr/>
        </p:nvSpPr>
        <p:spPr>
          <a:xfrm>
            <a:off x="4592588" y="4680059"/>
            <a:ext cx="6363412" cy="1574070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aseline="-25000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xmlns="" id="{ED080A0A-26A2-19D5-D43E-B3FE52637451}"/>
              </a:ext>
            </a:extLst>
          </p:cNvPr>
          <p:cNvSpPr/>
          <p:nvPr/>
        </p:nvSpPr>
        <p:spPr>
          <a:xfrm>
            <a:off x="4599111" y="4689534"/>
            <a:ext cx="430851" cy="26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xmlns="" id="{3F61B2B5-6DC2-29F1-BD4E-9B5FDCEF579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879833" y="4713966"/>
            <a:ext cx="2031957" cy="306873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xmlns="" id="{DD2D2239-E95A-A42E-D604-0B692532415F}"/>
              </a:ext>
            </a:extLst>
          </p:cNvPr>
          <p:cNvSpPr/>
          <p:nvPr/>
        </p:nvSpPr>
        <p:spPr>
          <a:xfrm>
            <a:off x="6000504" y="1041400"/>
            <a:ext cx="2696866" cy="3576215"/>
          </a:xfrm>
          <a:prstGeom prst="rect">
            <a:avLst/>
          </a:prstGeom>
          <a:noFill/>
          <a:ln w="19050">
            <a:solidFill>
              <a:srgbClr val="573EE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655C4607-02EA-28D0-54E6-31AE815C0CD0}"/>
              </a:ext>
            </a:extLst>
          </p:cNvPr>
          <p:cNvSpPr/>
          <p:nvPr/>
        </p:nvSpPr>
        <p:spPr>
          <a:xfrm>
            <a:off x="8729666" y="1039361"/>
            <a:ext cx="2189646" cy="3576215"/>
          </a:xfrm>
          <a:prstGeom prst="rect">
            <a:avLst/>
          </a:prstGeom>
          <a:noFill/>
          <a:ln w="190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1" name="图形 40">
            <a:extLst>
              <a:ext uri="{FF2B5EF4-FFF2-40B4-BE49-F238E27FC236}">
                <a16:creationId xmlns:a16="http://schemas.microsoft.com/office/drawing/2014/main" xmlns="" id="{8F4F00CB-1B8A-59F9-CF18-41ACC17AB2DD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xmlns="" r:embed="rId16"/>
              </a:ext>
            </a:extLst>
          </a:blip>
          <a:stretch>
            <a:fillRect/>
          </a:stretch>
        </p:blipFill>
        <p:spPr>
          <a:xfrm>
            <a:off x="4806664" y="1117600"/>
            <a:ext cx="6086083" cy="3465062"/>
          </a:xfrm>
          <a:prstGeom prst="rect">
            <a:avLst/>
          </a:prstGeom>
        </p:spPr>
      </p:pic>
      <p:grpSp>
        <p:nvGrpSpPr>
          <p:cNvPr id="34" name="组合 33">
            <a:extLst>
              <a:ext uri="{FF2B5EF4-FFF2-40B4-BE49-F238E27FC236}">
                <a16:creationId xmlns:a16="http://schemas.microsoft.com/office/drawing/2014/main" xmlns="" id="{16545023-FB16-FC8A-5591-AB3871BE6418}"/>
              </a:ext>
            </a:extLst>
          </p:cNvPr>
          <p:cNvGrpSpPr/>
          <p:nvPr/>
        </p:nvGrpSpPr>
        <p:grpSpPr>
          <a:xfrm>
            <a:off x="4917825" y="4749290"/>
            <a:ext cx="1664056" cy="1459060"/>
            <a:chOff x="1800294" y="542154"/>
            <a:chExt cx="6142703" cy="5773692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xmlns="" id="{6D038949-A94F-78BF-F5B4-71962AE76D6C}"/>
                </a:ext>
              </a:extLst>
            </p:cNvPr>
            <p:cNvGrpSpPr/>
            <p:nvPr/>
          </p:nvGrpSpPr>
          <p:grpSpPr>
            <a:xfrm>
              <a:off x="1800294" y="542154"/>
              <a:ext cx="6142703" cy="5773692"/>
              <a:chOff x="1800294" y="542154"/>
              <a:chExt cx="6142703" cy="5773692"/>
            </a:xfrm>
          </p:grpSpPr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xmlns="" id="{A6EFA581-FFFE-9E87-B7DB-48D5F1E7AD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800294" y="542154"/>
                <a:ext cx="6142703" cy="5773692"/>
              </a:xfrm>
              <a:prstGeom prst="rect">
                <a:avLst/>
              </a:prstGeom>
            </p:spPr>
          </p:pic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xmlns="" id="{3BBAEF04-8605-0FC2-6FCC-FAD18D698070}"/>
                  </a:ext>
                </a:extLst>
              </p:cNvPr>
              <p:cNvSpPr/>
              <p:nvPr/>
            </p:nvSpPr>
            <p:spPr>
              <a:xfrm>
                <a:off x="3125972" y="1812085"/>
                <a:ext cx="1123030" cy="4269738"/>
              </a:xfrm>
              <a:prstGeom prst="rect">
                <a:avLst/>
              </a:prstGeom>
              <a:solidFill>
                <a:srgbClr val="E7E6E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pic>
          <p:nvPicPr>
            <p:cNvPr id="36" name="图形 35">
              <a:extLst>
                <a:ext uri="{FF2B5EF4-FFF2-40B4-BE49-F238E27FC236}">
                  <a16:creationId xmlns:a16="http://schemas.microsoft.com/office/drawing/2014/main" xmlns="" id="{93A50A61-31C9-DF4B-710E-78B8A0C9A0A3}"/>
                </a:ext>
              </a:extLst>
            </p:cNvPr>
            <p:cNvPicPr>
              <a:picLocks/>
            </p:cNvPicPr>
            <p:nvPr/>
          </p:nvPicPr>
          <p:blipFill>
            <a:blip r:embed="rId18">
              <a:extLst>
                <a:ext uri="{96DAC541-7B7A-43D3-8B79-37D633B846F1}">
                  <asvg:svgBlip xmlns:asvg="http://schemas.microsoft.com/office/drawing/2016/SVG/main" xmlns="" r:embed="rId19"/>
                </a:ext>
              </a:extLst>
            </a:blip>
            <a:stretch>
              <a:fillRect/>
            </a:stretch>
          </p:blipFill>
          <p:spPr>
            <a:xfrm>
              <a:off x="3387023" y="1861549"/>
              <a:ext cx="792000" cy="216000"/>
            </a:xfrm>
            <a:prstGeom prst="rect">
              <a:avLst/>
            </a:prstGeom>
          </p:spPr>
        </p:pic>
        <p:pic>
          <p:nvPicPr>
            <p:cNvPr id="37" name="图形 36">
              <a:extLst>
                <a:ext uri="{FF2B5EF4-FFF2-40B4-BE49-F238E27FC236}">
                  <a16:creationId xmlns:a16="http://schemas.microsoft.com/office/drawing/2014/main" xmlns="" id="{4D8C1711-FFA9-F37D-EEAB-55090E0674F6}"/>
                </a:ext>
              </a:extLst>
            </p:cNvPr>
            <p:cNvPicPr>
              <a:picLocks/>
            </p:cNvPicPr>
            <p:nvPr/>
          </p:nvPicPr>
          <p:blipFill>
            <a:blip r:embed="rId20">
              <a:extLst>
                <a:ext uri="{96DAC541-7B7A-43D3-8B79-37D633B846F1}">
                  <asvg:svgBlip xmlns:asvg="http://schemas.microsoft.com/office/drawing/2016/SVG/main" xmlns="" r:embed="rId21"/>
                </a:ext>
              </a:extLst>
            </a:blip>
            <a:stretch>
              <a:fillRect/>
            </a:stretch>
          </p:blipFill>
          <p:spPr>
            <a:xfrm>
              <a:off x="3387023" y="2660493"/>
              <a:ext cx="792000" cy="216000"/>
            </a:xfrm>
            <a:prstGeom prst="rect">
              <a:avLst/>
            </a:prstGeom>
          </p:spPr>
        </p:pic>
        <p:pic>
          <p:nvPicPr>
            <p:cNvPr id="38" name="图形 37">
              <a:extLst>
                <a:ext uri="{FF2B5EF4-FFF2-40B4-BE49-F238E27FC236}">
                  <a16:creationId xmlns:a16="http://schemas.microsoft.com/office/drawing/2014/main" xmlns="" id="{584325FD-A8B8-C4CC-F0B1-FD0FBD9C9525}"/>
                </a:ext>
              </a:extLst>
            </p:cNvPr>
            <p:cNvPicPr>
              <a:picLocks/>
            </p:cNvPicPr>
            <p:nvPr/>
          </p:nvPicPr>
          <p:blipFill>
            <a:blip r:embed="rId22">
              <a:extLst>
                <a:ext uri="{96DAC541-7B7A-43D3-8B79-37D633B846F1}">
                  <asvg:svgBlip xmlns:asvg="http://schemas.microsoft.com/office/drawing/2016/SVG/main" xmlns="" r:embed="rId23"/>
                </a:ext>
              </a:extLst>
            </a:blip>
            <a:stretch>
              <a:fillRect/>
            </a:stretch>
          </p:blipFill>
          <p:spPr>
            <a:xfrm>
              <a:off x="3387023" y="3448192"/>
              <a:ext cx="792000" cy="216000"/>
            </a:xfrm>
            <a:prstGeom prst="rect">
              <a:avLst/>
            </a:prstGeom>
          </p:spPr>
        </p:pic>
        <p:pic>
          <p:nvPicPr>
            <p:cNvPr id="39" name="图形 38">
              <a:extLst>
                <a:ext uri="{FF2B5EF4-FFF2-40B4-BE49-F238E27FC236}">
                  <a16:creationId xmlns:a16="http://schemas.microsoft.com/office/drawing/2014/main" xmlns="" id="{0F549246-46C1-D0E7-D5C0-A433D85F0A32}"/>
                </a:ext>
              </a:extLst>
            </p:cNvPr>
            <p:cNvPicPr>
              <a:picLocks/>
            </p:cNvPicPr>
            <p:nvPr/>
          </p:nvPicPr>
          <p:blipFill>
            <a:blip r:embed="rId24">
              <a:extLst>
                <a:ext uri="{96DAC541-7B7A-43D3-8B79-37D633B846F1}">
                  <asvg:svgBlip xmlns:asvg="http://schemas.microsoft.com/office/drawing/2016/SVG/main" xmlns="" r:embed="rId25"/>
                </a:ext>
              </a:extLst>
            </a:blip>
            <a:stretch>
              <a:fillRect/>
            </a:stretch>
          </p:blipFill>
          <p:spPr>
            <a:xfrm>
              <a:off x="3387023" y="4235891"/>
              <a:ext cx="792000" cy="216000"/>
            </a:xfrm>
            <a:prstGeom prst="rect">
              <a:avLst/>
            </a:prstGeom>
          </p:spPr>
        </p:pic>
        <p:pic>
          <p:nvPicPr>
            <p:cNvPr id="40" name="图形 39">
              <a:extLst>
                <a:ext uri="{FF2B5EF4-FFF2-40B4-BE49-F238E27FC236}">
                  <a16:creationId xmlns:a16="http://schemas.microsoft.com/office/drawing/2014/main" xmlns="" id="{C98DEE1F-9064-6365-AC17-8C84AAF06272}"/>
                </a:ext>
              </a:extLst>
            </p:cNvPr>
            <p:cNvPicPr>
              <a:picLocks/>
            </p:cNvPicPr>
            <p:nvPr/>
          </p:nvPicPr>
          <p:blipFill>
            <a:blip r:embed="rId26">
              <a:extLst>
                <a:ext uri="{96DAC541-7B7A-43D3-8B79-37D633B846F1}">
                  <asvg:svgBlip xmlns:asvg="http://schemas.microsoft.com/office/drawing/2016/SVG/main" xmlns="" r:embed="rId27"/>
                </a:ext>
              </a:extLst>
            </a:blip>
            <a:stretch>
              <a:fillRect/>
            </a:stretch>
          </p:blipFill>
          <p:spPr>
            <a:xfrm>
              <a:off x="3387023" y="5050857"/>
              <a:ext cx="792000" cy="216000"/>
            </a:xfrm>
            <a:prstGeom prst="rect">
              <a:avLst/>
            </a:prstGeom>
          </p:spPr>
        </p:pic>
        <p:pic>
          <p:nvPicPr>
            <p:cNvPr id="42" name="图形 41">
              <a:extLst>
                <a:ext uri="{FF2B5EF4-FFF2-40B4-BE49-F238E27FC236}">
                  <a16:creationId xmlns:a16="http://schemas.microsoft.com/office/drawing/2014/main" xmlns="" id="{5A1C5C09-5A63-F04A-FC4F-9460AB8444AB}"/>
                </a:ext>
              </a:extLst>
            </p:cNvPr>
            <p:cNvPicPr>
              <a:picLocks/>
            </p:cNvPicPr>
            <p:nvPr/>
          </p:nvPicPr>
          <p:blipFill>
            <a:blip r:embed="rId28">
              <a:extLst>
                <a:ext uri="{96DAC541-7B7A-43D3-8B79-37D633B846F1}">
                  <asvg:svgBlip xmlns:asvg="http://schemas.microsoft.com/office/drawing/2016/SVG/main" xmlns="" r:embed="rId29"/>
                </a:ext>
              </a:extLst>
            </a:blip>
            <a:stretch>
              <a:fillRect/>
            </a:stretch>
          </p:blipFill>
          <p:spPr>
            <a:xfrm>
              <a:off x="3387023" y="5826064"/>
              <a:ext cx="792000" cy="216000"/>
            </a:xfrm>
            <a:prstGeom prst="rect">
              <a:avLst/>
            </a:prstGeom>
          </p:spPr>
        </p:pic>
      </p:grpSp>
      <p:sp>
        <p:nvSpPr>
          <p:cNvPr id="5" name="矩形 4">
            <a:extLst>
              <a:ext uri="{FF2B5EF4-FFF2-40B4-BE49-F238E27FC236}">
                <a16:creationId xmlns:a16="http://schemas.microsoft.com/office/drawing/2014/main" xmlns="" id="{90077DF6-491B-A0FB-0D5A-0C136E52561F}"/>
              </a:ext>
            </a:extLst>
          </p:cNvPr>
          <p:cNvSpPr/>
          <p:nvPr/>
        </p:nvSpPr>
        <p:spPr>
          <a:xfrm>
            <a:off x="5340882" y="854289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B7528B64-6AE7-4937-DDDC-E503746B505E}"/>
              </a:ext>
            </a:extLst>
          </p:cNvPr>
          <p:cNvSpPr/>
          <p:nvPr/>
        </p:nvSpPr>
        <p:spPr>
          <a:xfrm>
            <a:off x="8247557" y="854289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xmlns="" id="{D76F9BBA-7D9D-F1EB-1015-AA0A86494C9D}"/>
              </a:ext>
            </a:extLst>
          </p:cNvPr>
          <p:cNvSpPr/>
          <p:nvPr/>
        </p:nvSpPr>
        <p:spPr>
          <a:xfrm>
            <a:off x="10474297" y="854283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xmlns="" id="{4A5F8F4D-1B57-989D-15E6-3A4EC15D49C4}"/>
              </a:ext>
            </a:extLst>
          </p:cNvPr>
          <p:cNvSpPr txBox="1"/>
          <p:nvPr/>
        </p:nvSpPr>
        <p:spPr>
          <a:xfrm>
            <a:off x="11172829" y="0"/>
            <a:ext cx="1019171" cy="38093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ctr">
              <a:defRPr b="1"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defRPr>
            </a:lvl1pPr>
          </a:lstStyle>
          <a:p>
            <a:r>
              <a:rPr lang="en-US" altLang="zh-CN" dirty="0"/>
              <a:t>Fig. S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24199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31</TotalTime>
  <Words>26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xin</dc:creator>
  <cp:lastModifiedBy>Rene Carl Ventolero</cp:lastModifiedBy>
  <cp:revision>892</cp:revision>
  <dcterms:created xsi:type="dcterms:W3CDTF">2022-06-09T13:36:42Z</dcterms:created>
  <dcterms:modified xsi:type="dcterms:W3CDTF">2024-01-22T13:43:01Z</dcterms:modified>
</cp:coreProperties>
</file>